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9631A-A51A-4345-88D6-5E25C5CE7D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96169-B14A-406D-BFE6-61BFFB0F9B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F4E7B-BA64-45B6-AB16-199B1DFB5B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5BB5C-3967-470B-BCAD-0E56F7BAFE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023A5-4293-4852-BED1-50222895C1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2D008-9E82-4A3C-8CC9-A3266694E3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01F4C-CA35-4977-8B56-8FBAEA3ADC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B60C2D-C792-4CC9-B679-EB57EBB336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14269-825D-47CD-9119-2299C3062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BE219-A5C9-4547-BDAE-8986F2BC39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97321-9BCD-47D6-83F4-94F75EDA09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124D8-E607-4D9A-957F-FD2848B3FA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71FFB7-284E-45CE-BC88-80F0F5AF7C6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"/>
          <p:cNvGrpSpPr/>
          <p:nvPr/>
        </p:nvGrpSpPr>
        <p:grpSpPr>
          <a:xfrm>
            <a:off x="351000" y="944640"/>
            <a:ext cx="6140160" cy="5024520"/>
            <a:chOff x="351000" y="944640"/>
            <a:chExt cx="6140160" cy="5024520"/>
          </a:xfrm>
        </p:grpSpPr>
        <p:graphicFrame>
          <p:nvGraphicFramePr>
            <p:cNvPr id="42" name="Object 6"/>
            <p:cNvGraphicFramePr/>
            <p:nvPr/>
          </p:nvGraphicFramePr>
          <p:xfrm>
            <a:off x="351000" y="1198080"/>
            <a:ext cx="3283560" cy="21880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Object 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51000" y="1198080"/>
                      <a:ext cx="3283560" cy="2188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Object 8"/>
            <p:cNvGraphicFramePr/>
            <p:nvPr/>
          </p:nvGraphicFramePr>
          <p:xfrm>
            <a:off x="351000" y="3781080"/>
            <a:ext cx="3283560" cy="21880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5" name="Object 8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51000" y="3781080"/>
                      <a:ext cx="3283560" cy="2188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" name="TextBox 8"/>
            <p:cNvSpPr/>
            <p:nvPr/>
          </p:nvSpPr>
          <p:spPr>
            <a:xfrm>
              <a:off x="420120" y="944640"/>
              <a:ext cx="288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9"/>
            <p:cNvSpPr/>
            <p:nvPr/>
          </p:nvSpPr>
          <p:spPr>
            <a:xfrm>
              <a:off x="3453840" y="944640"/>
              <a:ext cx="288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0"/>
            <p:cNvSpPr/>
            <p:nvPr/>
          </p:nvSpPr>
          <p:spPr>
            <a:xfrm>
              <a:off x="420120" y="3531240"/>
              <a:ext cx="288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1"/>
            <p:cNvSpPr/>
            <p:nvPr/>
          </p:nvSpPr>
          <p:spPr>
            <a:xfrm>
              <a:off x="3453840" y="3531240"/>
              <a:ext cx="288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0" name="Object 7"/>
            <p:cNvGraphicFramePr/>
            <p:nvPr/>
          </p:nvGraphicFramePr>
          <p:xfrm>
            <a:off x="3207600" y="1198080"/>
            <a:ext cx="3283560" cy="218808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1" name="Object 7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3207600" y="1198080"/>
                      <a:ext cx="3283560" cy="2188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2" name="Object 10"/>
            <p:cNvGraphicFramePr/>
            <p:nvPr/>
          </p:nvGraphicFramePr>
          <p:xfrm>
            <a:off x="3207600" y="3780000"/>
            <a:ext cx="3283560" cy="218916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53" name="Object 10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207600" y="3780000"/>
                      <a:ext cx="3283560" cy="2189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54" name="TextBox 13"/>
          <p:cNvSpPr/>
          <p:nvPr/>
        </p:nvSpPr>
        <p:spPr>
          <a:xfrm>
            <a:off x="504720" y="6364440"/>
            <a:ext cx="583272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plan-Meier survival plots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. mellonell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arvae infected with the different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baumanni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rains. Time-kill results from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representative experiment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e show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which were obtained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y inoculating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A),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B),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C) or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7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D) bacterial cells per larva. Strains are: AYE (dashed red lines), ACICU (straight green lines), ATCC 17978 (dashed blue lines) and SDF (straight black lines). Statistically significant differences (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5 calculated by the log-rank test option of GraphPad) were only observed between SDF and the three clinical strains, but not between clinical strai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9T14:52:49Z</dcterms:created>
  <dc:creator>Luisa</dc:creator>
  <dc:description/>
  <dc:language>en-US</dc:language>
  <cp:lastModifiedBy>paolo.visca</cp:lastModifiedBy>
  <dcterms:modified xsi:type="dcterms:W3CDTF">2011-06-28T13:22:15Z</dcterms:modified>
  <cp:revision>16</cp:revision>
  <dc:subject/>
  <dc:title>Slide 1</dc:title>
</cp:coreProperties>
</file>